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456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ocrates2\data\Projects\Medical%20&amp;%20Scientific%20Affairs\Genesis\MEDICAL%20WRITING\CLINICAL%20STUDIES\APROACH_PsA\4.%20MANUSCRIPT\2.%20Drafts\v0.1\APROACH%20manuscript%20figure%203%20(raw%20data)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9301473169581165E-2"/>
          <c:y val="2.7716538182556951E-2"/>
          <c:w val="0.93529805933715204"/>
          <c:h val="0.86040110215399368"/>
        </c:manualLayout>
      </c:layout>
      <c:barChart>
        <c:barDir val="bar"/>
        <c:grouping val="clustered"/>
        <c:varyColors val="0"/>
        <c:ser>
          <c:idx val="0"/>
          <c:order val="0"/>
          <c:spPr>
            <a:noFill/>
            <a:ln>
              <a:noFill/>
            </a:ln>
            <a:effectLst/>
          </c:spPr>
          <c:invertIfNegative val="0"/>
          <c:cat>
            <c:strRef>
              <c:f>'Supplementary Table 2'!$A$3:$A$8</c:f>
              <c:strCache>
                <c:ptCount val="6"/>
                <c:pt idx="0">
                  <c:v>Presence of nail psoriasis at baseline</c:v>
                </c:pt>
                <c:pt idx="1">
                  <c:v>cDAPSA response at 16 weeks post-baseline</c:v>
                </c:pt>
                <c:pt idx="2">
                  <c:v>Duration of PsA at baseline</c:v>
                </c:pt>
                <c:pt idx="3">
                  <c:v>Presence of comorbidities at baseline</c:v>
                </c:pt>
                <c:pt idx="4">
                  <c:v>Obesity (BMI≥30 Kg/m2)</c:v>
                </c:pt>
                <c:pt idx="5">
                  <c:v>Age at baseline</c:v>
                </c:pt>
              </c:strCache>
            </c:strRef>
          </c:cat>
          <c:val>
            <c:numRef>
              <c:f>'Supplementary Table 2'!$B$3:$B$8</c:f>
              <c:numCache>
                <c:formatCode>General</c:formatCode>
                <c:ptCount val="6"/>
                <c:pt idx="0">
                  <c:v>2.0099999999999998</c:v>
                </c:pt>
                <c:pt idx="1">
                  <c:v>4.5599999999999996</c:v>
                </c:pt>
                <c:pt idx="2">
                  <c:v>0.47</c:v>
                </c:pt>
                <c:pt idx="3">
                  <c:v>0.26</c:v>
                </c:pt>
                <c:pt idx="4">
                  <c:v>0.4</c:v>
                </c:pt>
                <c:pt idx="5">
                  <c:v>1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04-45A1-840D-773F0BC2AC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23240608"/>
        <c:axId val="423238968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accent1"/>
              </a:solidFill>
              <a:ln w="9525">
                <a:noFill/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'Supplementary Table 2'!$F$3:$F$8</c:f>
                <c:numCache>
                  <c:formatCode>General</c:formatCode>
                  <c:ptCount val="6"/>
                  <c:pt idx="0">
                    <c:v>2.5</c:v>
                  </c:pt>
                  <c:pt idx="1">
                    <c:v>6.22</c:v>
                  </c:pt>
                  <c:pt idx="2">
                    <c:v>0.56000000000000005</c:v>
                  </c:pt>
                  <c:pt idx="3">
                    <c:v>0.35</c:v>
                  </c:pt>
                  <c:pt idx="4">
                    <c:v>0.52</c:v>
                  </c:pt>
                  <c:pt idx="5">
                    <c:v>4.0000000000000036E-2</c:v>
                  </c:pt>
                </c:numCache>
              </c:numRef>
            </c:plus>
            <c:minus>
              <c:numRef>
                <c:f>'Supplementary Table 2'!$D$3:$D$8</c:f>
                <c:numCache>
                  <c:formatCode>General</c:formatCode>
                  <c:ptCount val="6"/>
                  <c:pt idx="0">
                    <c:v>1.1199999999999997</c:v>
                  </c:pt>
                  <c:pt idx="1">
                    <c:v>2.63</c:v>
                  </c:pt>
                  <c:pt idx="2">
                    <c:v>0.26</c:v>
                  </c:pt>
                  <c:pt idx="3">
                    <c:v>0.15000000000000002</c:v>
                  </c:pt>
                  <c:pt idx="4">
                    <c:v>0.23</c:v>
                  </c:pt>
                  <c:pt idx="5">
                    <c:v>3.000000000000002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Supplementary Table 2'!$B$3:$B$8</c:f>
              <c:numCache>
                <c:formatCode>General</c:formatCode>
                <c:ptCount val="6"/>
                <c:pt idx="0">
                  <c:v>2.0099999999999998</c:v>
                </c:pt>
                <c:pt idx="1">
                  <c:v>4.5599999999999996</c:v>
                </c:pt>
                <c:pt idx="2">
                  <c:v>0.47</c:v>
                </c:pt>
                <c:pt idx="3">
                  <c:v>0.26</c:v>
                </c:pt>
                <c:pt idx="4">
                  <c:v>0.4</c:v>
                </c:pt>
                <c:pt idx="5">
                  <c:v>1.04</c:v>
                </c:pt>
              </c:numCache>
            </c:numRef>
          </c:xVal>
          <c:yVal>
            <c:numRef>
              <c:f>'Supplementary Table 2'!$G$3:$G$8</c:f>
              <c:numCache>
                <c:formatCode>General</c:formatCode>
                <c:ptCount val="6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004-45A1-840D-773F0BC2AC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3256680"/>
        <c:axId val="423250776"/>
      </c:scatterChart>
      <c:catAx>
        <c:axId val="42324060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low"/>
        <c:crossAx val="423238968"/>
        <c:crosses val="autoZero"/>
        <c:auto val="1"/>
        <c:lblAlgn val="ctr"/>
        <c:lblOffset val="100"/>
        <c:noMultiLvlLbl val="0"/>
      </c:catAx>
      <c:valAx>
        <c:axId val="423238968"/>
        <c:scaling>
          <c:logBase val="10"/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>
                    <a:solidFill>
                      <a:schemeClr val="tx1"/>
                    </a:solidFill>
                  </a:rPr>
                  <a:t>Odds Ratio</a:t>
                </a:r>
                <a:endParaRPr lang="el-GR" sz="140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3240608"/>
        <c:crosses val="autoZero"/>
        <c:crossBetween val="between"/>
        <c:majorUnit val="1"/>
      </c:valAx>
      <c:valAx>
        <c:axId val="423250776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423256680"/>
        <c:crosses val="max"/>
        <c:crossBetween val="midCat"/>
      </c:valAx>
      <c:valAx>
        <c:axId val="423256680"/>
        <c:scaling>
          <c:logBase val="10"/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232507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4711</cdr:x>
      <cdr:y>0.05037</cdr:y>
    </cdr:from>
    <cdr:to>
      <cdr:x>0.34711</cdr:x>
      <cdr:y>0.89317</cdr:y>
    </cdr:to>
    <cdr:cxnSp macro="">
      <cdr:nvCxnSpPr>
        <cdr:cNvPr id="3" name="Ευθεία γραμμή σύνδεσης 2">
          <a:extLst xmlns:a="http://schemas.openxmlformats.org/drawingml/2006/main">
            <a:ext uri="{FF2B5EF4-FFF2-40B4-BE49-F238E27FC236}">
              <a16:creationId xmlns:a16="http://schemas.microsoft.com/office/drawing/2014/main" id="{F2520055-66D5-4265-ADCB-9D73197344DF}"/>
            </a:ext>
          </a:extLst>
        </cdr:cNvPr>
        <cdr:cNvCxnSpPr/>
      </cdr:nvCxnSpPr>
      <cdr:spPr>
        <a:xfrm xmlns:a="http://schemas.openxmlformats.org/drawingml/2006/main">
          <a:off x="1208722" y="245909"/>
          <a:ext cx="0" cy="4114597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A60776-498F-562B-EB86-044BF9BAC6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BF3FA8-23F1-F593-9577-A8B081E81E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32B94F-C2B5-9435-867A-3DE97E09F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2A954A-ECEB-59B8-F06E-676AA88214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AA7E30-DB25-3CD5-BDC1-F465D5FFF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320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4AE150-FCEA-B407-7472-5917145DEA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344C29-5F15-2BAB-9014-0532BFC5D4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4BB463-9141-4BDB-CA2A-F4F1CF385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AF88BA-B4A3-EF0A-0C6E-343D11184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682318-E394-E2DA-2FEE-FE2BD0482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99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6E927C-279B-2C80-6985-969826CFCE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1B732C-DE7C-5B51-89A5-95588ED9C5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71B963-D967-2530-325B-8B2311F59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146FFE-84E6-77E3-5506-F53196B09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2013BB-F184-66AC-3641-51286125A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145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1446A-3DD0-5614-5F31-A0D04B26CF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3B5CA8-0F00-B478-7790-2F3FB6A3E3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4EC51B-140A-9D3A-ACDB-D01A0A149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5FE1C1-36E9-F9FA-8F1B-3CCC26482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D0B0CA-2AC4-A97F-B743-56FFFC6C3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900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2B12E5-F1A8-5253-A02F-4BE0FF08EC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61ECF1-37CD-B748-E845-B08B2C5AB7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DECB77-153A-CC11-8AC7-8CCEF7F72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06F886-147B-9E2F-0FF4-21DB12E04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6DE0AF-4E16-D24C-F6E1-CAD3516BE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041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EC5307-CD24-8868-2569-5187621EBE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2C3339-7601-ABE6-8C00-B173045928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ECC4D2-F617-82B2-CF2D-E244676BAB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0CA4AF-2141-0B5B-4AAD-A93BE14CB0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528FB0-8B6E-6919-E4A6-026C7932F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4B2D4F-0A1C-EBE4-AD9A-0BE5886014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561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88D432-FEE3-785E-575C-B9D87715FE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E7D01B-E35D-21D9-16FC-10D384D108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FB1041-4FFB-339E-4821-6400BD2733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71D1860-AAF1-8758-8F1B-EA3D65805C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9D901C4-6C1B-2977-C719-2015C09333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327DB1-14EF-3042-F520-602891838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6FE071-5199-D50E-ECDC-B949A56D6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69AA7-E69D-2A92-CBFB-FBDFACE53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5868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59F7A8-456C-13D4-5784-77CEC84DB5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5F769E-4BE5-3DC7-58F7-4D7F53886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A35950-ECDF-9D57-32EF-B418E1C8A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C064663-D711-2F68-D135-AC3CA95892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55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ACAB14-2842-E95C-2531-E06E628FF1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2857876-E6C0-8DCF-C923-132205003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C28790-5EED-D6F6-2455-19E7BDE340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331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A4163E-566C-775C-B747-5F1522E83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1C5F13-8CC2-D23E-C3F6-4ACE69EACB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CFCA1F-8CEB-3D6C-420F-8CDCF90909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008B5E-CCD9-DD25-B0BB-0BCB834642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1A8527-3ED6-D56C-D33E-F4771A245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1AA8B6-93EE-05E5-4025-E4A9C19F8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792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A87E6C-7AAD-A91C-BFDB-918931E7B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A3CA33-DBBD-EBAA-AE4B-929081E5A9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936E74-AC36-7D01-D9CF-7750D3210B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D67D92-B427-AA79-09CE-524727C5C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7B01EC-66D8-0E41-AC03-78BFE8F4B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9C29D7-3059-A826-384D-ADC09E1C4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489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56B1692-65E9-4095-EC4A-CDFCA88120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27C2CE-224C-431F-9377-839DCAF357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BDDC21-66DF-D41E-3EFC-02376344E8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9173B-E77E-443F-AAC9-996DCBE97AD6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813D71-C65C-C630-26F2-1670F3459D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E3D0E0-E8FB-278E-BC52-36B5157D25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D4432-31FC-4BDD-9FB4-51FA7BFFB7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874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D63499D-BDE8-803F-C681-067B68FD5AD4}"/>
              </a:ext>
            </a:extLst>
          </p:cNvPr>
          <p:cNvSpPr txBox="1"/>
          <p:nvPr/>
        </p:nvSpPr>
        <p:spPr>
          <a:xfrm>
            <a:off x="3047802" y="1450731"/>
            <a:ext cx="68611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upplementary </a:t>
            </a:r>
            <a:r>
              <a:rPr lang="en-US" b="1">
                <a:solidFill>
                  <a:srgbClr val="000000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igure 2</a:t>
            </a:r>
            <a:endParaRPr lang="el-GR" dirty="0">
              <a:solidFill>
                <a:srgbClr val="000000"/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graphicFrame>
        <p:nvGraphicFramePr>
          <p:cNvPr id="5" name="Πίνακας 4">
            <a:extLst>
              <a:ext uri="{FF2B5EF4-FFF2-40B4-BE49-F238E27FC236}">
                <a16:creationId xmlns:a16="http://schemas.microsoft.com/office/drawing/2014/main" id="{D28571DF-9725-2DEA-6272-60E4D1DDE3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9377052"/>
              </p:ext>
            </p:extLst>
          </p:nvPr>
        </p:nvGraphicFramePr>
        <p:xfrm>
          <a:off x="2234947" y="3432567"/>
          <a:ext cx="2718147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50423">
                  <a:extLst>
                    <a:ext uri="{9D8B030D-6E8A-4147-A177-3AD203B41FA5}">
                      <a16:colId xmlns:a16="http://schemas.microsoft.com/office/drawing/2014/main" val="2262689875"/>
                    </a:ext>
                  </a:extLst>
                </a:gridCol>
                <a:gridCol w="967724">
                  <a:extLst>
                    <a:ext uri="{9D8B030D-6E8A-4147-A177-3AD203B41FA5}">
                      <a16:colId xmlns:a16="http://schemas.microsoft.com/office/drawing/2014/main" val="3403443179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inuous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6273193"/>
                  </a:ext>
                </a:extLst>
              </a:tr>
            </a:tbl>
          </a:graphicData>
        </a:graphic>
      </p:graphicFrame>
      <p:graphicFrame>
        <p:nvGraphicFramePr>
          <p:cNvPr id="6" name="Πίνακας 5">
            <a:extLst>
              <a:ext uri="{FF2B5EF4-FFF2-40B4-BE49-F238E27FC236}">
                <a16:creationId xmlns:a16="http://schemas.microsoft.com/office/drawing/2014/main" id="{835B7443-006A-5CEE-EBDC-261D305115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0306268"/>
              </p:ext>
            </p:extLst>
          </p:nvPr>
        </p:nvGraphicFramePr>
        <p:xfrm>
          <a:off x="2290688" y="3878353"/>
          <a:ext cx="2718148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59131">
                  <a:extLst>
                    <a:ext uri="{9D8B030D-6E8A-4147-A177-3AD203B41FA5}">
                      <a16:colId xmlns:a16="http://schemas.microsoft.com/office/drawing/2014/main" val="1810368686"/>
                    </a:ext>
                  </a:extLst>
                </a:gridCol>
                <a:gridCol w="959017">
                  <a:extLst>
                    <a:ext uri="{9D8B030D-6E8A-4147-A177-3AD203B41FA5}">
                      <a16:colId xmlns:a16="http://schemas.microsoft.com/office/drawing/2014/main" val="730924208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marL="0" algn="r" defTabSz="914400" rtl="0" eaLnBrk="1" latinLnBrk="0" hangingPunct="1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kern="1200" dirty="0" err="1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besity</a:t>
                      </a:r>
                      <a:r>
                        <a:rPr lang="el-GR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(BMI≥30 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k</a:t>
                      </a:r>
                      <a:r>
                        <a:rPr lang="el-GR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/m</a:t>
                      </a:r>
                      <a:r>
                        <a:rPr lang="el-GR" sz="1200" kern="1200" baseline="300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lang="el-GR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kern="1200" dirty="0" err="1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Yes</a:t>
                      </a:r>
                      <a:r>
                        <a:rPr lang="el-GR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kern="1200" dirty="0" err="1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vs</a:t>
                      </a:r>
                      <a:r>
                        <a:rPr lang="el-GR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kern="1200" dirty="0" err="1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</a:t>
                      </a:r>
                      <a:endParaRPr lang="el-GR" sz="12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6950077"/>
                  </a:ext>
                </a:extLst>
              </a:tr>
            </a:tbl>
          </a:graphicData>
        </a:graphic>
      </p:graphicFrame>
      <p:graphicFrame>
        <p:nvGraphicFramePr>
          <p:cNvPr id="7" name="Πίνακας 6">
            <a:extLst>
              <a:ext uri="{FF2B5EF4-FFF2-40B4-BE49-F238E27FC236}">
                <a16:creationId xmlns:a16="http://schemas.microsoft.com/office/drawing/2014/main" id="{54ABC1D8-6EC9-8913-427F-676FC7BAD4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0585817"/>
              </p:ext>
            </p:extLst>
          </p:nvPr>
        </p:nvGraphicFramePr>
        <p:xfrm>
          <a:off x="1441994" y="4339637"/>
          <a:ext cx="3554172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29990">
                  <a:extLst>
                    <a:ext uri="{9D8B030D-6E8A-4147-A177-3AD203B41FA5}">
                      <a16:colId xmlns:a16="http://schemas.microsoft.com/office/drawing/2014/main" val="1764584835"/>
                    </a:ext>
                  </a:extLst>
                </a:gridCol>
                <a:gridCol w="924182">
                  <a:extLst>
                    <a:ext uri="{9D8B030D-6E8A-4147-A177-3AD203B41FA5}">
                      <a16:colId xmlns:a16="http://schemas.microsoft.com/office/drawing/2014/main" val="2472913053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ce of comorbidities at baseline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1097669"/>
                  </a:ext>
                </a:extLst>
              </a:tr>
            </a:tbl>
          </a:graphicData>
        </a:graphic>
      </p:graphicFrame>
      <p:graphicFrame>
        <p:nvGraphicFramePr>
          <p:cNvPr id="8" name="Πίνακας 7">
            <a:extLst>
              <a:ext uri="{FF2B5EF4-FFF2-40B4-BE49-F238E27FC236}">
                <a16:creationId xmlns:a16="http://schemas.microsoft.com/office/drawing/2014/main" id="{341D90CC-9EAE-82FD-A988-4AA47EFF66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6563192"/>
              </p:ext>
            </p:extLst>
          </p:nvPr>
        </p:nvGraphicFramePr>
        <p:xfrm>
          <a:off x="1788395" y="4779753"/>
          <a:ext cx="3108960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02097">
                  <a:extLst>
                    <a:ext uri="{9D8B030D-6E8A-4147-A177-3AD203B41FA5}">
                      <a16:colId xmlns:a16="http://schemas.microsoft.com/office/drawing/2014/main" val="4084007527"/>
                    </a:ext>
                  </a:extLst>
                </a:gridCol>
                <a:gridCol w="1106863">
                  <a:extLst>
                    <a:ext uri="{9D8B030D-6E8A-4147-A177-3AD203B41FA5}">
                      <a16:colId xmlns:a16="http://schemas.microsoft.com/office/drawing/2014/main" val="1114926728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ration of PsA at baseline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≥1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ars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443527"/>
                  </a:ext>
                </a:extLst>
              </a:tr>
            </a:tbl>
          </a:graphicData>
        </a:graphic>
      </p:graphicFrame>
      <p:graphicFrame>
        <p:nvGraphicFramePr>
          <p:cNvPr id="9" name="Πίνακας 8">
            <a:extLst>
              <a:ext uri="{FF2B5EF4-FFF2-40B4-BE49-F238E27FC236}">
                <a16:creationId xmlns:a16="http://schemas.microsoft.com/office/drawing/2014/main" id="{04277E04-2CAA-60CE-7280-3E1D0EDC8FA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8945528"/>
              </p:ext>
            </p:extLst>
          </p:nvPr>
        </p:nvGraphicFramePr>
        <p:xfrm>
          <a:off x="801523" y="5231210"/>
          <a:ext cx="4207315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265716">
                  <a:extLst>
                    <a:ext uri="{9D8B030D-6E8A-4147-A177-3AD203B41FA5}">
                      <a16:colId xmlns:a16="http://schemas.microsoft.com/office/drawing/2014/main" val="2493562825"/>
                    </a:ext>
                  </a:extLst>
                </a:gridCol>
                <a:gridCol w="941599">
                  <a:extLst>
                    <a:ext uri="{9D8B030D-6E8A-4147-A177-3AD203B41FA5}">
                      <a16:colId xmlns:a16="http://schemas.microsoft.com/office/drawing/2014/main" val="28014250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APSA</a:t>
                      </a: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sponse at 16 weeks post-baseline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6265123"/>
                  </a:ext>
                </a:extLst>
              </a:tr>
            </a:tbl>
          </a:graphicData>
        </a:graphic>
      </p:graphicFrame>
      <p:graphicFrame>
        <p:nvGraphicFramePr>
          <p:cNvPr id="10" name="Πίνακας 9">
            <a:extLst>
              <a:ext uri="{FF2B5EF4-FFF2-40B4-BE49-F238E27FC236}">
                <a16:creationId xmlns:a16="http://schemas.microsoft.com/office/drawing/2014/main" id="{A15304C5-54D0-8600-1DA0-74B8856070F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8715289"/>
              </p:ext>
            </p:extLst>
          </p:nvPr>
        </p:nvGraphicFramePr>
        <p:xfrm>
          <a:off x="1350166" y="5678653"/>
          <a:ext cx="3658673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717074">
                  <a:extLst>
                    <a:ext uri="{9D8B030D-6E8A-4147-A177-3AD203B41FA5}">
                      <a16:colId xmlns:a16="http://schemas.microsoft.com/office/drawing/2014/main" val="276382912"/>
                    </a:ext>
                  </a:extLst>
                </a:gridCol>
                <a:gridCol w="941599">
                  <a:extLst>
                    <a:ext uri="{9D8B030D-6E8A-4147-A177-3AD203B41FA5}">
                      <a16:colId xmlns:a16="http://schemas.microsoft.com/office/drawing/2014/main" val="1042488501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ence of nail psoriasis at baseline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535600"/>
                  </a:ext>
                </a:extLst>
              </a:tr>
            </a:tbl>
          </a:graphicData>
        </a:graphic>
      </p:graphicFrame>
      <p:graphicFrame>
        <p:nvGraphicFramePr>
          <p:cNvPr id="11" name="Πίνακας 10">
            <a:extLst>
              <a:ext uri="{FF2B5EF4-FFF2-40B4-BE49-F238E27FC236}">
                <a16:creationId xmlns:a16="http://schemas.microsoft.com/office/drawing/2014/main" id="{48F5A686-29DA-5D5B-0CA4-5716965DC8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8392555"/>
              </p:ext>
            </p:extLst>
          </p:nvPr>
        </p:nvGraphicFramePr>
        <p:xfrm>
          <a:off x="8340759" y="3436307"/>
          <a:ext cx="3038168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59542">
                  <a:extLst>
                    <a:ext uri="{9D8B030D-6E8A-4147-A177-3AD203B41FA5}">
                      <a16:colId xmlns:a16="http://schemas.microsoft.com/office/drawing/2014/main" val="2206109674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2879001166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2000736477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1848633841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</a:t>
                      </a:r>
                      <a:endParaRPr lang="el-G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2222394"/>
                  </a:ext>
                </a:extLst>
              </a:tr>
            </a:tbl>
          </a:graphicData>
        </a:graphic>
      </p:graphicFrame>
      <p:graphicFrame>
        <p:nvGraphicFramePr>
          <p:cNvPr id="12" name="Πίνακας 11">
            <a:extLst>
              <a:ext uri="{FF2B5EF4-FFF2-40B4-BE49-F238E27FC236}">
                <a16:creationId xmlns:a16="http://schemas.microsoft.com/office/drawing/2014/main" id="{65DB805D-DB33-68DB-DB0F-A553394DCC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2963067"/>
              </p:ext>
            </p:extLst>
          </p:nvPr>
        </p:nvGraphicFramePr>
        <p:xfrm>
          <a:off x="8340759" y="3878353"/>
          <a:ext cx="3038168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59542">
                  <a:extLst>
                    <a:ext uri="{9D8B030D-6E8A-4147-A177-3AD203B41FA5}">
                      <a16:colId xmlns:a16="http://schemas.microsoft.com/office/drawing/2014/main" val="472835829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2283017185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714672428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2976557574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2</a:t>
                      </a:r>
                      <a:endParaRPr lang="el-G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3901354"/>
                  </a:ext>
                </a:extLst>
              </a:tr>
            </a:tbl>
          </a:graphicData>
        </a:graphic>
      </p:graphicFrame>
      <p:graphicFrame>
        <p:nvGraphicFramePr>
          <p:cNvPr id="13" name="Πίνακας 12">
            <a:extLst>
              <a:ext uri="{FF2B5EF4-FFF2-40B4-BE49-F238E27FC236}">
                <a16:creationId xmlns:a16="http://schemas.microsoft.com/office/drawing/2014/main" id="{2680A70D-AB0B-1569-A94B-921570F1C1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3976146"/>
              </p:ext>
            </p:extLst>
          </p:nvPr>
        </p:nvGraphicFramePr>
        <p:xfrm>
          <a:off x="8340759" y="4344299"/>
          <a:ext cx="3038168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59542">
                  <a:extLst>
                    <a:ext uri="{9D8B030D-6E8A-4147-A177-3AD203B41FA5}">
                      <a16:colId xmlns:a16="http://schemas.microsoft.com/office/drawing/2014/main" val="2041320452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3491420607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3166643348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2892114515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l-G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1121917"/>
                  </a:ext>
                </a:extLst>
              </a:tr>
            </a:tbl>
          </a:graphicData>
        </a:graphic>
      </p:graphicFrame>
      <p:graphicFrame>
        <p:nvGraphicFramePr>
          <p:cNvPr id="14" name="Πίνακας 13">
            <a:extLst>
              <a:ext uri="{FF2B5EF4-FFF2-40B4-BE49-F238E27FC236}">
                <a16:creationId xmlns:a16="http://schemas.microsoft.com/office/drawing/2014/main" id="{AA4D4371-F1A3-DBAB-2D2D-9EDDCE7724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5017951"/>
              </p:ext>
            </p:extLst>
          </p:nvPr>
        </p:nvGraphicFramePr>
        <p:xfrm>
          <a:off x="8340759" y="4783767"/>
          <a:ext cx="3038168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59542">
                  <a:extLst>
                    <a:ext uri="{9D8B030D-6E8A-4147-A177-3AD203B41FA5}">
                      <a16:colId xmlns:a16="http://schemas.microsoft.com/office/drawing/2014/main" val="1114422211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1315429959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2222183116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320918281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1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485352"/>
                  </a:ext>
                </a:extLst>
              </a:tr>
            </a:tbl>
          </a:graphicData>
        </a:graphic>
      </p:graphicFrame>
      <p:graphicFrame>
        <p:nvGraphicFramePr>
          <p:cNvPr id="15" name="Πίνακας 14">
            <a:extLst>
              <a:ext uri="{FF2B5EF4-FFF2-40B4-BE49-F238E27FC236}">
                <a16:creationId xmlns:a16="http://schemas.microsoft.com/office/drawing/2014/main" id="{7C376D46-B6CC-ED51-2AAA-C82EB8940E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4967078"/>
              </p:ext>
            </p:extLst>
          </p:nvPr>
        </p:nvGraphicFramePr>
        <p:xfrm>
          <a:off x="8340759" y="5231210"/>
          <a:ext cx="3038168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59542">
                  <a:extLst>
                    <a:ext uri="{9D8B030D-6E8A-4147-A177-3AD203B41FA5}">
                      <a16:colId xmlns:a16="http://schemas.microsoft.com/office/drawing/2014/main" val="1479334412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3013270850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1535301370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1975548806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6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3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78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l-G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622834"/>
                  </a:ext>
                </a:extLst>
              </a:tr>
            </a:tbl>
          </a:graphicData>
        </a:graphic>
      </p:graphicFrame>
      <p:graphicFrame>
        <p:nvGraphicFramePr>
          <p:cNvPr id="16" name="Πίνακας 15">
            <a:extLst>
              <a:ext uri="{FF2B5EF4-FFF2-40B4-BE49-F238E27FC236}">
                <a16:creationId xmlns:a16="http://schemas.microsoft.com/office/drawing/2014/main" id="{716942D1-AD09-0DFB-54F4-617ECE1240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5099034"/>
              </p:ext>
            </p:extLst>
          </p:nvPr>
        </p:nvGraphicFramePr>
        <p:xfrm>
          <a:off x="8340759" y="5678653"/>
          <a:ext cx="3038168" cy="1835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59542">
                  <a:extLst>
                    <a:ext uri="{9D8B030D-6E8A-4147-A177-3AD203B41FA5}">
                      <a16:colId xmlns:a16="http://schemas.microsoft.com/office/drawing/2014/main" val="1256346207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3375350280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2495061940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3421675236"/>
                    </a:ext>
                  </a:extLst>
                </a:gridCol>
              </a:tblGrid>
              <a:tr h="1835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1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1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1558733"/>
                  </a:ext>
                </a:extLst>
              </a:tr>
            </a:tbl>
          </a:graphicData>
        </a:graphic>
      </p:graphicFrame>
      <p:graphicFrame>
        <p:nvGraphicFramePr>
          <p:cNvPr id="17" name="Πίνακας 16">
            <a:extLst>
              <a:ext uri="{FF2B5EF4-FFF2-40B4-BE49-F238E27FC236}">
                <a16:creationId xmlns:a16="http://schemas.microsoft.com/office/drawing/2014/main" id="{849E698F-2D4C-936B-D4EE-D07079A23F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8838807"/>
              </p:ext>
            </p:extLst>
          </p:nvPr>
        </p:nvGraphicFramePr>
        <p:xfrm>
          <a:off x="2321301" y="2936704"/>
          <a:ext cx="3429000" cy="3486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45920">
                  <a:extLst>
                    <a:ext uri="{9D8B030D-6E8A-4147-A177-3AD203B41FA5}">
                      <a16:colId xmlns:a16="http://schemas.microsoft.com/office/drawing/2014/main" val="3742529050"/>
                    </a:ext>
                  </a:extLst>
                </a:gridCol>
                <a:gridCol w="1783080">
                  <a:extLst>
                    <a:ext uri="{9D8B030D-6E8A-4147-A177-3AD203B41FA5}">
                      <a16:colId xmlns:a16="http://schemas.microsoft.com/office/drawing/2014/main" val="560942760"/>
                    </a:ext>
                  </a:extLst>
                </a:gridCol>
              </a:tblGrid>
              <a:tr h="348615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0391522"/>
                  </a:ext>
                </a:extLst>
              </a:tr>
            </a:tbl>
          </a:graphicData>
        </a:graphic>
      </p:graphicFrame>
      <p:graphicFrame>
        <p:nvGraphicFramePr>
          <p:cNvPr id="18" name="Πίνακας 17">
            <a:extLst>
              <a:ext uri="{FF2B5EF4-FFF2-40B4-BE49-F238E27FC236}">
                <a16:creationId xmlns:a16="http://schemas.microsoft.com/office/drawing/2014/main" id="{06FF6526-E5EC-7BC8-7774-0A51454912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9647198"/>
              </p:ext>
            </p:extLst>
          </p:nvPr>
        </p:nvGraphicFramePr>
        <p:xfrm>
          <a:off x="8389849" y="2588085"/>
          <a:ext cx="3038167" cy="69723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43511">
                  <a:extLst>
                    <a:ext uri="{9D8B030D-6E8A-4147-A177-3AD203B41FA5}">
                      <a16:colId xmlns:a16="http://schemas.microsoft.com/office/drawing/2014/main" val="3030764796"/>
                    </a:ext>
                  </a:extLst>
                </a:gridCol>
                <a:gridCol w="853440">
                  <a:extLst>
                    <a:ext uri="{9D8B030D-6E8A-4147-A177-3AD203B41FA5}">
                      <a16:colId xmlns:a16="http://schemas.microsoft.com/office/drawing/2014/main" val="2102284884"/>
                    </a:ext>
                  </a:extLst>
                </a:gridCol>
                <a:gridCol w="881674">
                  <a:extLst>
                    <a:ext uri="{9D8B030D-6E8A-4147-A177-3AD203B41FA5}">
                      <a16:colId xmlns:a16="http://schemas.microsoft.com/office/drawing/2014/main" val="4031085423"/>
                    </a:ext>
                  </a:extLst>
                </a:gridCol>
                <a:gridCol w="759542">
                  <a:extLst>
                    <a:ext uri="{9D8B030D-6E8A-4147-A177-3AD203B41FA5}">
                      <a16:colId xmlns:a16="http://schemas.microsoft.com/office/drawing/2014/main" val="1400140632"/>
                    </a:ext>
                  </a:extLst>
                </a:gridCol>
              </a:tblGrid>
              <a:tr h="3486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5% CI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l-GR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7572670"/>
                  </a:ext>
                </a:extLst>
              </a:tr>
              <a:tr h="3486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er</a:t>
                      </a: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it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per limit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l-GR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</a:t>
                      </a:r>
                      <a:r>
                        <a:rPr lang="el-GR" sz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el-G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0" marR="38100" marT="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0671844"/>
                  </a:ext>
                </a:extLst>
              </a:tr>
            </a:tbl>
          </a:graphicData>
        </a:graphic>
      </p:graphicFrame>
      <p:graphicFrame>
        <p:nvGraphicFramePr>
          <p:cNvPr id="19" name="Θέση περιεχομένου 9">
            <a:extLst>
              <a:ext uri="{FF2B5EF4-FFF2-40B4-BE49-F238E27FC236}">
                <a16:creationId xmlns:a16="http://schemas.microsoft.com/office/drawing/2014/main" id="{F6EA6D51-948C-3DD6-7A66-208479BDB8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903353"/>
              </p:ext>
            </p:extLst>
          </p:nvPr>
        </p:nvGraphicFramePr>
        <p:xfrm>
          <a:off x="5008837" y="3224935"/>
          <a:ext cx="3482235" cy="3117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59852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8</Words>
  <Application>Microsoft Office PowerPoint</Application>
  <PresentationFormat>Widescreen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agiota Karagianni</dc:creator>
  <cp:lastModifiedBy>Panagiota Karagianni</cp:lastModifiedBy>
  <cp:revision>1</cp:revision>
  <dcterms:created xsi:type="dcterms:W3CDTF">2022-09-06T07:57:24Z</dcterms:created>
  <dcterms:modified xsi:type="dcterms:W3CDTF">2022-09-06T07:57:58Z</dcterms:modified>
</cp:coreProperties>
</file>